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3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PCNA</a:t>
            </a:r>
            <a:r>
              <a:rPr lang="en-GB" sz="1600" dirty="0" smtClean="0"/>
              <a:t> gene. A) Wild (Template </a:t>
            </a:r>
            <a:r>
              <a:rPr lang="en-US" sz="1600" dirty="0" smtClean="0"/>
              <a:t>1u7b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u7b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214290"/>
            <a:ext cx="3271848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71415"/>
            <a:ext cx="3606800" cy="292895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071810"/>
            <a:ext cx="3286148" cy="28762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214686"/>
            <a:ext cx="3571900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8</cp:revision>
  <dcterms:created xsi:type="dcterms:W3CDTF">2018-05-10T07:33:24Z</dcterms:created>
  <dcterms:modified xsi:type="dcterms:W3CDTF">2018-05-29T07:37:26Z</dcterms:modified>
</cp:coreProperties>
</file>